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197"/>
  </p:normalViewPr>
  <p:slideViewPr>
    <p:cSldViewPr snapToGrid="0" snapToObjects="1">
      <p:cViewPr varScale="1">
        <p:scale>
          <a:sx n="119" d="100"/>
          <a:sy n="119" d="100"/>
        </p:scale>
        <p:origin x="21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BE94F2-86AC-4C4A-A30A-E68882F04E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7D8291B-966D-194E-80E6-FEFA1D13977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405B1E-F9EC-E641-A939-3E06B3C45B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FADA0-01B9-1D4A-8ACE-B448EFEC0C09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4B62EA-6E8A-104A-A66C-8732D3A7B5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0041D9-115B-B044-B139-C32B913D5E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7E99C-055E-004C-A18E-A760620A0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372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C09860-7742-E34E-8E5F-848C7DEE3E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24C81C-F687-014D-BC57-4235C97ECA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A45E2A-A2FC-C345-88A6-E753673459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FADA0-01B9-1D4A-8ACE-B448EFEC0C09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D0B5CC-E65D-8A4A-849F-5E1957F8A3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5C1837-AB87-D447-8C39-3E0709F22B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7E99C-055E-004C-A18E-A760620A0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12650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16E4698-1904-6C4A-8961-29F237F728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CE0EC8-792F-0346-BEDC-0A0640C957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453A6A-6317-C24B-B8CE-5ABAE4CFBC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FADA0-01B9-1D4A-8ACE-B448EFEC0C09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882C19-6E4D-964C-9AC5-B90481E58F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8EF5A6-CE90-7440-A89F-464D4A4FC7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7E99C-055E-004C-A18E-A760620A0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9967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E9AEF6-1948-BD44-8D37-1B2300617B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93DCA4A-FD32-0F40-8C61-1422FEE94A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BED553-8735-C242-BD1E-A1FFFDF160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FADA0-01B9-1D4A-8ACE-B448EFEC0C09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B857C8-D495-EB44-B706-D9D188B587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A79886-0165-CC40-9836-1D67AF89D0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7E99C-055E-004C-A18E-A760620A0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82067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79330C-D0FA-924B-B24F-0E5704E2C3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DC7B74-140E-2842-B59D-2598E5E7E2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C1D308-79CC-AB4F-B318-514203EF15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FADA0-01B9-1D4A-8ACE-B448EFEC0C09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9FF8D4-B0A5-F04C-AA50-9BC94194AB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8AE445-C17D-A543-A8E8-DB1DA11379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7E99C-055E-004C-A18E-A760620A0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3007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F64D92-6CB7-D44E-8431-2CB778E28A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593564-1CEC-9A4A-8042-3D5D14A4D1D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ED74B9D-A5E6-D64A-96AA-303AD799BE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835BD6-8E2E-044B-A617-58BE16A9E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FADA0-01B9-1D4A-8ACE-B448EFEC0C09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600C0A-CE08-A64F-B6F0-B7CF37831D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114D2B-E49A-F949-9A19-88D3BBBE03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7E99C-055E-004C-A18E-A760620A0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0705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7D780F-DDF2-054C-9268-A949D2C637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7D341FC-9DE7-2B48-8ED2-BF2FEA8225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B7C294C-A843-C443-A96B-F3BD00ADB1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7A5084C-DE22-E048-999F-EAD74322FBD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7095208-A891-A944-AF51-F4F1AE8008E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3F2C776-E0C7-4B45-A3E9-5ADC44EABA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FADA0-01B9-1D4A-8ACE-B448EFEC0C09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DBA8ED8-96C1-DA4A-938A-20D3F8A0D3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DEA6601-CDBA-B848-8BFB-006C9C222D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7E99C-055E-004C-A18E-A760620A0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71135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F7CD14-D1A9-144E-B65A-75E9C8411F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3D53709-8BC2-4B4C-A148-87D0FBE59B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FADA0-01B9-1D4A-8ACE-B448EFEC0C09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CEFC34F-5269-3B4E-9811-2F692154D7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91F08DA-6E21-A74E-964B-40A949DAFC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7E99C-055E-004C-A18E-A760620A0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6032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7F7A822-84AB-974E-95F1-69747DD0A7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FADA0-01B9-1D4A-8ACE-B448EFEC0C09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5D2D67F-EB13-AE47-B0D1-227308A10E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1A2E7F4-A01C-4544-9EC8-CF08A80FC1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7E99C-055E-004C-A18E-A760620A0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1297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6CEC9A-7417-2E49-9B04-91FA39E9D7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E8875C-DE48-6348-94E1-375EF14FD9A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745D1B-A075-A343-93CF-EB71A78AF8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9BA3D4-AAEB-F144-A185-D3D0F08723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FADA0-01B9-1D4A-8ACE-B448EFEC0C09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7D6FAE-A9ED-4A44-B009-A8499BD920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E44861-DB93-B64A-8F6C-5CBACF626B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7E99C-055E-004C-A18E-A760620A0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259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582D1C-CF5D-D543-BBF8-086E7A4CC3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81F63E8-8721-134F-B256-3EFB7E87426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CE5EEFD-2A41-574C-978E-03028B2D97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1BC3C44-C122-0B41-9AD7-9BA76B65C0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FADA0-01B9-1D4A-8ACE-B448EFEC0C09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EEAC8F4-6828-5948-BE33-C872FF2C24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DF1684-A462-CC45-B77D-62F29B09BA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7E99C-055E-004C-A18E-A760620A0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0496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B2B265E-5195-714B-B4C9-35C22BBAD4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034A9B-B11C-374D-A2AD-2E02EECC93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A4E70E-5230-9C47-9F28-8F58A4A6B88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AFADA0-01B9-1D4A-8ACE-B448EFEC0C09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47EF20-6D5D-364D-B86E-2B534DD7909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7CEB1D-AB56-4844-97CB-727AAAE7153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A7E99C-055E-004C-A18E-A760620A0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6595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B348ADE5-13C2-404B-80E2-B459F2E79ED7}"/>
              </a:ext>
            </a:extLst>
          </p:cNvPr>
          <p:cNvGrpSpPr/>
          <p:nvPr/>
        </p:nvGrpSpPr>
        <p:grpSpPr>
          <a:xfrm>
            <a:off x="3455377" y="422889"/>
            <a:ext cx="5281246" cy="6012222"/>
            <a:chOff x="3455377" y="301172"/>
            <a:chExt cx="5281246" cy="6012222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5EA8145A-4BB9-B044-8E37-8A186D0819CB}"/>
                </a:ext>
              </a:extLst>
            </p:cNvPr>
            <p:cNvGrpSpPr/>
            <p:nvPr/>
          </p:nvGrpSpPr>
          <p:grpSpPr>
            <a:xfrm>
              <a:off x="3455377" y="544605"/>
              <a:ext cx="5281246" cy="5768789"/>
              <a:chOff x="-87086" y="707678"/>
              <a:chExt cx="7041661" cy="7691719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9FC2A9BB-3D89-8B45-91D7-5BE6D27C1FA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-87086" y="707678"/>
                <a:ext cx="4830208" cy="7691719"/>
              </a:xfrm>
              <a:prstGeom prst="rect">
                <a:avLst/>
              </a:prstGeom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488C7880-8BE4-264F-AE2A-D66AE2D5CFFD}"/>
                  </a:ext>
                </a:extLst>
              </p:cNvPr>
              <p:cNvSpPr txBox="1"/>
              <p:nvPr/>
            </p:nvSpPr>
            <p:spPr>
              <a:xfrm>
                <a:off x="2362200" y="729675"/>
                <a:ext cx="4176785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elaginella </a:t>
                </a:r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ellendorffii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elaginellac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,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ycophyta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F5A71FED-6CB2-ED4C-9275-C53D5FAB95FF}"/>
                  </a:ext>
                </a:extLst>
              </p:cNvPr>
              <p:cNvSpPr txBox="1"/>
              <p:nvPr/>
            </p:nvSpPr>
            <p:spPr>
              <a:xfrm>
                <a:off x="2201906" y="999617"/>
                <a:ext cx="2345086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huja </a:t>
                </a:r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licata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Cupressaceae)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4A31F98E-5E0B-4E46-B248-086ECFAAE6C1}"/>
                  </a:ext>
                </a:extLst>
              </p:cNvPr>
              <p:cNvSpPr txBox="1"/>
              <p:nvPr/>
            </p:nvSpPr>
            <p:spPr>
              <a:xfrm>
                <a:off x="1660820" y="7467604"/>
                <a:ext cx="3371007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phagnum </a:t>
                </a:r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allax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phagnac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,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yophyta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6DF8654E-1953-D944-BF7E-B06E205021EE}"/>
                  </a:ext>
                </a:extLst>
              </p:cNvPr>
              <p:cNvSpPr txBox="1"/>
              <p:nvPr/>
            </p:nvSpPr>
            <p:spPr>
              <a:xfrm>
                <a:off x="1604192" y="7737546"/>
                <a:ext cx="3687334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hyscomitrella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atens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unariac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,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yophyta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D564F2FF-C7A5-B548-9F15-AA6DB245BFD3}"/>
                  </a:ext>
                </a:extLst>
              </p:cNvPr>
              <p:cNvSpPr txBox="1"/>
              <p:nvPr/>
            </p:nvSpPr>
            <p:spPr>
              <a:xfrm>
                <a:off x="4249436" y="7190605"/>
                <a:ext cx="2595156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aphanus sativus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Brassicaceae)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EC59048F-38EE-9F4C-BA80-93D5ED781EFA}"/>
                  </a:ext>
                </a:extLst>
              </p:cNvPr>
              <p:cNvSpPr txBox="1"/>
              <p:nvPr/>
            </p:nvSpPr>
            <p:spPr>
              <a:xfrm>
                <a:off x="4536819" y="6922316"/>
                <a:ext cx="2417756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ssica </a:t>
                </a:r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apus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Brassicaceae)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6887D709-84F9-7E4A-A49D-08006F187FB3}"/>
                  </a:ext>
                </a:extLst>
              </p:cNvPr>
              <p:cNvSpPr txBox="1"/>
              <p:nvPr/>
            </p:nvSpPr>
            <p:spPr>
              <a:xfrm>
                <a:off x="3959668" y="6650512"/>
                <a:ext cx="2875147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rabidopsis thaliana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Brassicaceae)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6F1A87AE-75EA-F046-83F6-87FC8DA1592A}"/>
                  </a:ext>
                </a:extLst>
              </p:cNvPr>
              <p:cNvSpPr txBox="1"/>
              <p:nvPr/>
            </p:nvSpPr>
            <p:spPr>
              <a:xfrm>
                <a:off x="3509100" y="6385736"/>
                <a:ext cx="2353636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lycine max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eguminos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BCA7D42B-7D6C-6443-B426-93D42966D9CC}"/>
                  </a:ext>
                </a:extLst>
              </p:cNvPr>
              <p:cNvSpPr txBox="1"/>
              <p:nvPr/>
            </p:nvSpPr>
            <p:spPr>
              <a:xfrm>
                <a:off x="3678444" y="6122640"/>
                <a:ext cx="2554545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ucalyptus grandis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yrtac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1D38AC8D-C468-9A44-A70B-E4AF3C45507F}"/>
                  </a:ext>
                </a:extLst>
              </p:cNvPr>
              <p:cNvSpPr txBox="1"/>
              <p:nvPr/>
            </p:nvSpPr>
            <p:spPr>
              <a:xfrm>
                <a:off x="3371193" y="5836092"/>
                <a:ext cx="2385696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urio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zibethinus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lvac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291E60EE-DD9A-5B4F-A34D-3DF091143E46}"/>
                  </a:ext>
                </a:extLst>
              </p:cNvPr>
              <p:cNvSpPr txBox="1"/>
              <p:nvPr/>
            </p:nvSpPr>
            <p:spPr>
              <a:xfrm>
                <a:off x="3454462" y="5575700"/>
                <a:ext cx="2667825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ossypium </a:t>
                </a:r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irsutum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lvac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BB058F22-5C1B-A443-8D24-9684B884FB54}"/>
                  </a:ext>
                </a:extLst>
              </p:cNvPr>
              <p:cNvSpPr txBox="1"/>
              <p:nvPr/>
            </p:nvSpPr>
            <p:spPr>
              <a:xfrm>
                <a:off x="3651910" y="5298972"/>
                <a:ext cx="2704159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ucurbis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axima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Cucurbitaceae)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03744E04-4F6F-D74D-869B-90481D03D22B}"/>
                  </a:ext>
                </a:extLst>
              </p:cNvPr>
              <p:cNvSpPr txBox="1"/>
              <p:nvPr/>
            </p:nvSpPr>
            <p:spPr>
              <a:xfrm>
                <a:off x="3174322" y="5035877"/>
                <a:ext cx="2127079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itrus sinensis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utac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D5F90CF9-1911-2840-8745-F5BDDB2D90CD}"/>
                  </a:ext>
                </a:extLst>
              </p:cNvPr>
              <p:cNvSpPr txBox="1"/>
              <p:nvPr/>
            </p:nvSpPr>
            <p:spPr>
              <a:xfrm>
                <a:off x="3032595" y="4758038"/>
                <a:ext cx="2129216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Quercus </a:t>
                </a:r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ber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Fagaceae)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7B6AA186-5602-3F47-845A-CA21911A5CDB}"/>
                  </a:ext>
                </a:extLst>
              </p:cNvPr>
              <p:cNvSpPr txBox="1"/>
              <p:nvPr/>
            </p:nvSpPr>
            <p:spPr>
              <a:xfrm>
                <a:off x="3409318" y="4495738"/>
                <a:ext cx="1949680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rus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nota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rac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D2AC6A39-F10D-7B43-82CE-DD34C1C7D2B3}"/>
                  </a:ext>
                </a:extLst>
              </p:cNvPr>
              <p:cNvSpPr txBox="1"/>
              <p:nvPr/>
            </p:nvSpPr>
            <p:spPr>
              <a:xfrm>
                <a:off x="3165613" y="4233438"/>
                <a:ext cx="2080056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unus </a:t>
                </a:r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me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Rosaceae)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3B03788C-F026-1248-AB75-05AD804FE85A}"/>
                  </a:ext>
                </a:extLst>
              </p:cNvPr>
              <p:cNvSpPr txBox="1"/>
              <p:nvPr/>
            </p:nvSpPr>
            <p:spPr>
              <a:xfrm>
                <a:off x="3223658" y="3954507"/>
                <a:ext cx="2642177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opulus </a:t>
                </a:r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richocarpa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Salicaceae)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63D7932A-3A0A-F946-9E6C-21ED2B728BF2}"/>
                  </a:ext>
                </a:extLst>
              </p:cNvPr>
              <p:cNvSpPr txBox="1"/>
              <p:nvPr/>
            </p:nvSpPr>
            <p:spPr>
              <a:xfrm>
                <a:off x="3165613" y="3696858"/>
                <a:ext cx="2800340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nihot esculenta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uphorbiac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CBE8A287-05F3-2943-9654-8F1BA87FCA54}"/>
                  </a:ext>
                </a:extLst>
              </p:cNvPr>
              <p:cNvSpPr txBox="1"/>
              <p:nvPr/>
            </p:nvSpPr>
            <p:spPr>
              <a:xfrm>
                <a:off x="2849067" y="3419063"/>
                <a:ext cx="1962504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itis vinifera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Vitaceae)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1BD74BF9-AFF9-9B4C-9B99-1228EA71E0B4}"/>
                  </a:ext>
                </a:extLst>
              </p:cNvPr>
              <p:cNvSpPr txBox="1"/>
              <p:nvPr/>
            </p:nvSpPr>
            <p:spPr>
              <a:xfrm>
                <a:off x="3307837" y="3151403"/>
                <a:ext cx="2545996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lianthus annuus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Asteraceae)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BFF29540-2797-8E45-AC09-6E6C70AFC8F1}"/>
                  </a:ext>
                </a:extLst>
              </p:cNvPr>
              <p:cNvSpPr txBox="1"/>
              <p:nvPr/>
            </p:nvSpPr>
            <p:spPr>
              <a:xfrm>
                <a:off x="3455127" y="2881181"/>
                <a:ext cx="2582332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icotiana tabacum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Solanaceae)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24AE9E62-1731-1E4F-9BCB-D98655EF6F25}"/>
                  </a:ext>
                </a:extLst>
              </p:cNvPr>
              <p:cNvSpPr txBox="1"/>
              <p:nvPr/>
            </p:nvSpPr>
            <p:spPr>
              <a:xfrm>
                <a:off x="3139098" y="2606571"/>
                <a:ext cx="2135628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lea europaea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Oleaceae)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1C665A15-33BD-F640-ABED-0DB8E07ADEBF}"/>
                  </a:ext>
                </a:extLst>
              </p:cNvPr>
              <p:cNvSpPr txBox="1"/>
              <p:nvPr/>
            </p:nvSpPr>
            <p:spPr>
              <a:xfrm>
                <a:off x="3214997" y="2342339"/>
                <a:ext cx="2481876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eta vulgaris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maranthac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84A66F20-1129-2C4E-B601-C54E7263CEA0}"/>
                  </a:ext>
                </a:extLst>
              </p:cNvPr>
              <p:cNvSpPr txBox="1"/>
              <p:nvPr/>
            </p:nvSpPr>
            <p:spPr>
              <a:xfrm>
                <a:off x="3086003" y="2069925"/>
                <a:ext cx="2858048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quilegia </a:t>
                </a:r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erulea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Ranunculaceae)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359DF4EC-F21C-D241-8896-265E05BDD524}"/>
                  </a:ext>
                </a:extLst>
              </p:cNvPr>
              <p:cNvSpPr txBox="1"/>
              <p:nvPr/>
            </p:nvSpPr>
            <p:spPr>
              <a:xfrm>
                <a:off x="3010881" y="1801406"/>
                <a:ext cx="2962777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halaenopsis </a:t>
                </a:r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questris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rchidac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87BA161A-029D-B24A-8069-6192449778BE}"/>
                  </a:ext>
                </a:extLst>
              </p:cNvPr>
              <p:cNvSpPr txBox="1"/>
              <p:nvPr/>
            </p:nvSpPr>
            <p:spPr>
              <a:xfrm>
                <a:off x="2806363" y="1532207"/>
                <a:ext cx="2327988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sa acuminata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Musaceae)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0344BBB4-D8AD-5445-A42F-D0B20F5F2805}"/>
                  </a:ext>
                </a:extLst>
              </p:cNvPr>
              <p:cNvSpPr txBox="1"/>
              <p:nvPr/>
            </p:nvSpPr>
            <p:spPr>
              <a:xfrm>
                <a:off x="2478118" y="1262107"/>
                <a:ext cx="3140176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mborella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richocarpa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mborellac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1E88E5AA-6F4F-0249-9B9B-803E188ACD78}"/>
                  </a:ext>
                </a:extLst>
              </p:cNvPr>
              <p:cNvSpPr txBox="1"/>
              <p:nvPr/>
            </p:nvSpPr>
            <p:spPr>
              <a:xfrm>
                <a:off x="1785609" y="3130535"/>
                <a:ext cx="494152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99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8E47E729-5E81-6D47-8FEC-8DEB52D0A818}"/>
                  </a:ext>
                </a:extLst>
              </p:cNvPr>
              <p:cNvSpPr txBox="1"/>
              <p:nvPr/>
            </p:nvSpPr>
            <p:spPr>
              <a:xfrm>
                <a:off x="1642715" y="2684621"/>
                <a:ext cx="494152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99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6E8421F6-1F51-9045-A734-4D20D296CF42}"/>
                  </a:ext>
                </a:extLst>
              </p:cNvPr>
              <p:cNvSpPr txBox="1"/>
              <p:nvPr/>
            </p:nvSpPr>
            <p:spPr>
              <a:xfrm>
                <a:off x="2116417" y="6094486"/>
                <a:ext cx="494152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92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2378ADEE-D081-D44B-9165-07897A23313C}"/>
                  </a:ext>
                </a:extLst>
              </p:cNvPr>
              <p:cNvSpPr txBox="1"/>
              <p:nvPr/>
            </p:nvSpPr>
            <p:spPr>
              <a:xfrm>
                <a:off x="2528933" y="5463748"/>
                <a:ext cx="494152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92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2F9204F1-3624-F349-85E9-D775B2009BD3}"/>
                  </a:ext>
                </a:extLst>
              </p:cNvPr>
              <p:cNvSpPr txBox="1"/>
              <p:nvPr/>
            </p:nvSpPr>
            <p:spPr>
              <a:xfrm>
                <a:off x="298141" y="7754797"/>
                <a:ext cx="42362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334076D6-DA08-3E41-A6DB-031F1F635DBD}"/>
                  </a:ext>
                </a:extLst>
              </p:cNvPr>
              <p:cNvSpPr txBox="1"/>
              <p:nvPr/>
            </p:nvSpPr>
            <p:spPr>
              <a:xfrm>
                <a:off x="3065147" y="7004022"/>
                <a:ext cx="42362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ACF12640-6A85-434A-88EF-AFACC982B31A}"/>
                  </a:ext>
                </a:extLst>
              </p:cNvPr>
              <p:cNvSpPr txBox="1"/>
              <p:nvPr/>
            </p:nvSpPr>
            <p:spPr>
              <a:xfrm>
                <a:off x="3711306" y="7208821"/>
                <a:ext cx="42362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AF8237CB-9747-C54D-AE9B-0F419B686702}"/>
                  </a:ext>
                </a:extLst>
              </p:cNvPr>
              <p:cNvSpPr txBox="1"/>
              <p:nvPr/>
            </p:nvSpPr>
            <p:spPr>
              <a:xfrm>
                <a:off x="2726417" y="5861969"/>
                <a:ext cx="42362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4095E7A7-9173-6E43-95A9-2571BC1C3F7D}"/>
                  </a:ext>
                </a:extLst>
              </p:cNvPr>
              <p:cNvSpPr txBox="1"/>
              <p:nvPr/>
            </p:nvSpPr>
            <p:spPr>
              <a:xfrm>
                <a:off x="2526410" y="4647914"/>
                <a:ext cx="42362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61289E87-A1B9-2E47-A124-4EC3A2C0038B}"/>
                  </a:ext>
                </a:extLst>
              </p:cNvPr>
              <p:cNvSpPr txBox="1"/>
              <p:nvPr/>
            </p:nvSpPr>
            <p:spPr>
              <a:xfrm>
                <a:off x="2100249" y="4408274"/>
                <a:ext cx="42362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2FE258D8-1A54-F042-A5D9-2BA26B5D775C}"/>
                  </a:ext>
                </a:extLst>
              </p:cNvPr>
              <p:cNvSpPr txBox="1"/>
              <p:nvPr/>
            </p:nvSpPr>
            <p:spPr>
              <a:xfrm>
                <a:off x="2419685" y="3724023"/>
                <a:ext cx="42362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82D16643-14A0-DD44-B911-A755BBD01EB2}"/>
                  </a:ext>
                </a:extLst>
              </p:cNvPr>
              <p:cNvSpPr txBox="1"/>
              <p:nvPr/>
            </p:nvSpPr>
            <p:spPr>
              <a:xfrm>
                <a:off x="2103045" y="2856797"/>
                <a:ext cx="42362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E06084D5-50A4-E748-8947-667811E2D74B}"/>
                  </a:ext>
                </a:extLst>
              </p:cNvPr>
              <p:cNvSpPr txBox="1"/>
              <p:nvPr/>
            </p:nvSpPr>
            <p:spPr>
              <a:xfrm>
                <a:off x="2253917" y="2650511"/>
                <a:ext cx="42362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F82C98D1-300C-C245-8E84-F9328F7CAA5A}"/>
                  </a:ext>
                </a:extLst>
              </p:cNvPr>
              <p:cNvSpPr txBox="1"/>
              <p:nvPr/>
            </p:nvSpPr>
            <p:spPr>
              <a:xfrm>
                <a:off x="1551551" y="2246039"/>
                <a:ext cx="42362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8387FDE9-5CA7-8841-ADFC-907A7C54763E}"/>
                  </a:ext>
                </a:extLst>
              </p:cNvPr>
              <p:cNvSpPr txBox="1"/>
              <p:nvPr/>
            </p:nvSpPr>
            <p:spPr>
              <a:xfrm>
                <a:off x="1848989" y="1822499"/>
                <a:ext cx="42362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864DCAD9-B1F6-614B-9555-6B2CC074B7BA}"/>
                  </a:ext>
                </a:extLst>
              </p:cNvPr>
              <p:cNvSpPr txBox="1"/>
              <p:nvPr/>
            </p:nvSpPr>
            <p:spPr>
              <a:xfrm>
                <a:off x="1179141" y="1836249"/>
                <a:ext cx="42362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289494AA-42A5-314E-9BDC-DB18EAEE7A1C}"/>
                  </a:ext>
                </a:extLst>
              </p:cNvPr>
              <p:cNvSpPr txBox="1"/>
              <p:nvPr/>
            </p:nvSpPr>
            <p:spPr>
              <a:xfrm>
                <a:off x="664342" y="1490835"/>
                <a:ext cx="42362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C5E28220-4744-8C49-B52F-73FCC0C7A6B1}"/>
                  </a:ext>
                </a:extLst>
              </p:cNvPr>
              <p:cNvSpPr txBox="1"/>
              <p:nvPr/>
            </p:nvSpPr>
            <p:spPr>
              <a:xfrm>
                <a:off x="302419" y="1185215"/>
                <a:ext cx="42362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64EA7FA5-FF30-C648-95A5-ADE1AF659879}"/>
                  </a:ext>
                </a:extLst>
              </p:cNvPr>
              <p:cNvSpPr txBox="1"/>
              <p:nvPr/>
            </p:nvSpPr>
            <p:spPr>
              <a:xfrm>
                <a:off x="2250870" y="5265540"/>
                <a:ext cx="42362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cxnSp>
            <p:nvCxnSpPr>
              <p:cNvPr id="56" name="Straight Connector 55">
                <a:extLst>
                  <a:ext uri="{FF2B5EF4-FFF2-40B4-BE49-F238E27FC236}">
                    <a16:creationId xmlns:a16="http://schemas.microsoft.com/office/drawing/2014/main" id="{E702B119-2EED-B04B-91CF-55196A7D343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478118" y="6074369"/>
                <a:ext cx="163626" cy="15427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Straight Connector 58">
                <a:extLst>
                  <a:ext uri="{FF2B5EF4-FFF2-40B4-BE49-F238E27FC236}">
                    <a16:creationId xmlns:a16="http://schemas.microsoft.com/office/drawing/2014/main" id="{233FD6FA-997A-AB41-9ABE-50A4EAD0A84C}"/>
                  </a:ext>
                </a:extLst>
              </p:cNvPr>
              <p:cNvCxnSpPr/>
              <p:nvPr/>
            </p:nvCxnSpPr>
            <p:spPr>
              <a:xfrm>
                <a:off x="2641744" y="5326402"/>
                <a:ext cx="0" cy="183496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594A61EB-A04C-E548-B18D-63D08CA887A1}"/>
                  </a:ext>
                </a:extLst>
              </p:cNvPr>
              <p:cNvSpPr txBox="1"/>
              <p:nvPr/>
            </p:nvSpPr>
            <p:spPr>
              <a:xfrm>
                <a:off x="1981739" y="3760695"/>
                <a:ext cx="42362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cxnSp>
            <p:nvCxnSpPr>
              <p:cNvPr id="61" name="Straight Connector 60">
                <a:extLst>
                  <a:ext uri="{FF2B5EF4-FFF2-40B4-BE49-F238E27FC236}">
                    <a16:creationId xmlns:a16="http://schemas.microsoft.com/office/drawing/2014/main" id="{B3F508F0-ABE3-C143-A36A-734B00736C08}"/>
                  </a:ext>
                </a:extLst>
              </p:cNvPr>
              <p:cNvCxnSpPr/>
              <p:nvPr/>
            </p:nvCxnSpPr>
            <p:spPr>
              <a:xfrm>
                <a:off x="2638871" y="4521274"/>
                <a:ext cx="0" cy="183496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63C60C90-CF5D-EE41-88A0-3C8436FFFC5B}"/>
                </a:ext>
              </a:extLst>
            </p:cNvPr>
            <p:cNvSpPr txBox="1"/>
            <p:nvPr/>
          </p:nvSpPr>
          <p:spPr>
            <a:xfrm>
              <a:off x="3681677" y="301172"/>
              <a:ext cx="130997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CDC22 </a:t>
              </a:r>
              <a:r>
                <a: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ucleotid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996221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63</Words>
  <Application>Microsoft Macintosh PowerPoint</Application>
  <PresentationFormat>Widescreen</PresentationFormat>
  <Paragraphs>4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nnor Lewis</dc:creator>
  <cp:lastModifiedBy>Connor Lewis</cp:lastModifiedBy>
  <cp:revision>2</cp:revision>
  <dcterms:created xsi:type="dcterms:W3CDTF">2022-09-13T16:47:29Z</dcterms:created>
  <dcterms:modified xsi:type="dcterms:W3CDTF">2022-11-18T19:10:05Z</dcterms:modified>
</cp:coreProperties>
</file>